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576AEAE-A2DE-430B-9965-51F2E0998160}" v="1" dt="2023-05-10T22:46:10.407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68" d="100"/>
          <a:sy n="68" d="100"/>
        </p:scale>
        <p:origin x="66" y="33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Erica Dsouza" userId="af8277e8-2569-4c95-99a7-ee6c4417b387" providerId="ADAL" clId="{6576AEAE-A2DE-430B-9965-51F2E0998160}"/>
    <pc:docChg chg="modSld">
      <pc:chgData name="Erica Dsouza" userId="af8277e8-2569-4c95-99a7-ee6c4417b387" providerId="ADAL" clId="{6576AEAE-A2DE-430B-9965-51F2E0998160}" dt="2023-05-10T22:46:13.469" v="3" actId="2"/>
      <pc:docMkLst>
        <pc:docMk/>
      </pc:docMkLst>
      <pc:sldChg chg="modSp mod">
        <pc:chgData name="Erica Dsouza" userId="af8277e8-2569-4c95-99a7-ee6c4417b387" providerId="ADAL" clId="{6576AEAE-A2DE-430B-9965-51F2E0998160}" dt="2023-05-10T22:46:13.469" v="3" actId="2"/>
        <pc:sldMkLst>
          <pc:docMk/>
          <pc:sldMk cId="2048024578" sldId="258"/>
        </pc:sldMkLst>
        <pc:graphicFrameChg chg="modGraphic">
          <ac:chgData name="Erica Dsouza" userId="af8277e8-2569-4c95-99a7-ee6c4417b387" providerId="ADAL" clId="{6576AEAE-A2DE-430B-9965-51F2E0998160}" dt="2023-05-10T22:46:13.469" v="3" actId="2"/>
          <ac:graphicFrameMkLst>
            <pc:docMk/>
            <pc:sldMk cId="2048024578" sldId="258"/>
            <ac:graphicFrameMk id="279" creationId="{C14DE845-190B-4CAA-ADAF-0F62AD337949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BBE36FA-B01F-48C7-B129-1D1B8D3D139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91D2939B-D918-4588-9567-4E762259C76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8479F0C-DFD5-417E-AE17-F663B9443D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38CDD8-93CD-4644-BA9B-AD1F7738B8B3}" type="datetimeFigureOut">
              <a:rPr kumimoji="1" lang="ja-JP" altLang="en-US" smtClean="0"/>
              <a:t>2023/5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1694F33-88F5-446F-BC1E-F5CD5B3AF6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FF30F44-5A80-4903-ACCB-A0A2D28EC4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39ED7-6F6B-4589-A7D7-93F90FBDE1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0757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8F99CD7-A379-46D1-8B6A-9C170BE73E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6917D5A-0B06-42D0-B5D7-ADC2334140C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2C10116-17DC-4F64-B9EC-D60790A69C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38CDD8-93CD-4644-BA9B-AD1F7738B8B3}" type="datetimeFigureOut">
              <a:rPr kumimoji="1" lang="ja-JP" altLang="en-US" smtClean="0"/>
              <a:t>2023/5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E57B906-7AAE-4255-B60F-FEE1D42920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A2033D5-5EEA-4CF5-A045-11165C0759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39ED7-6F6B-4589-A7D7-93F90FBDE1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1859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3B76EE75-85AD-4CFB-838D-E8140DD56FA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C173AE4-40B0-49B5-957D-D6B14B1B79C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2B2EFA2-FC8A-4702-851C-CD1CB5B04A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38CDD8-93CD-4644-BA9B-AD1F7738B8B3}" type="datetimeFigureOut">
              <a:rPr kumimoji="1" lang="ja-JP" altLang="en-US" smtClean="0"/>
              <a:t>2023/5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7DF9C67-CA32-4D64-B04E-1D908C904A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77F1BBE-11BF-4C0F-AAE5-C449E6326D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39ED7-6F6B-4589-A7D7-93F90FBDE1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69014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BDA2FB1-23BE-423E-88C0-D8E2771918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CBE4928-D7A9-42D5-A287-6188987D119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F219539-00BE-4FCC-9F1E-2212CC92D8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38CDD8-93CD-4644-BA9B-AD1F7738B8B3}" type="datetimeFigureOut">
              <a:rPr kumimoji="1" lang="ja-JP" altLang="en-US" smtClean="0"/>
              <a:t>2023/5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E630DE5-9FF6-4156-BFB0-12DF600DA3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7A83B28-5120-442E-9DBD-1541C47747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39ED7-6F6B-4589-A7D7-93F90FBDE1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07339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32F3D2E-3AD5-4376-92B1-C10A564CBA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4D76474-EAA6-4819-B0B1-031AEE4096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1419C7F-D5AF-4F8A-8575-A07DCE62CB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38CDD8-93CD-4644-BA9B-AD1F7738B8B3}" type="datetimeFigureOut">
              <a:rPr kumimoji="1" lang="ja-JP" altLang="en-US" smtClean="0"/>
              <a:t>2023/5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A1FA5D1-CEB6-4F55-A866-212FC0EB12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7945720-2D23-4583-A3A7-F893E6CE78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39ED7-6F6B-4589-A7D7-93F90FBDE1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38079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F00BBBE-E4F8-4D8E-874F-5F6F259AAD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498BE3C-C699-4664-9E62-932AE768E48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DB3A5E1-75DE-4FAA-8A44-03DBFAAEEC5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6D8188E-37FA-4D28-ACF9-9C8EF7C23C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38CDD8-93CD-4644-BA9B-AD1F7738B8B3}" type="datetimeFigureOut">
              <a:rPr kumimoji="1" lang="ja-JP" altLang="en-US" smtClean="0"/>
              <a:t>2023/5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FC62AA5-741B-45B1-ACE5-CB4D8F1ED7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799564A-10FA-43C5-AAA3-2E85836C6C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39ED7-6F6B-4589-A7D7-93F90FBDE1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68978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39F9751-FE79-496D-AA20-6143485BEE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530980D-6769-4BF8-9230-94B6D6A454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27123F2-8A14-409E-9D26-2639BAD3926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654151E7-514C-4B0F-8463-CB5F8470837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76D21C38-E116-422C-B8AD-8BAE78C63DF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BB97299C-C591-418F-A603-3733EA71B5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38CDD8-93CD-4644-BA9B-AD1F7738B8B3}" type="datetimeFigureOut">
              <a:rPr kumimoji="1" lang="ja-JP" altLang="en-US" smtClean="0"/>
              <a:t>2023/5/1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7BC7CEF6-1C82-4E38-A118-80E2EE6534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CE76E0F2-8FC9-4F26-9958-AA136BA0D7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39ED7-6F6B-4589-A7D7-93F90FBDE1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77315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67245BB-CCD2-4DB5-80EC-99E647AE0D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6BE7826D-C3BE-43D3-BBC5-36B885EE6B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38CDD8-93CD-4644-BA9B-AD1F7738B8B3}" type="datetimeFigureOut">
              <a:rPr kumimoji="1" lang="ja-JP" altLang="en-US" smtClean="0"/>
              <a:t>2023/5/1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7F0B9137-0C2A-4EE7-A1D5-CACC10B1EE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5EA782C0-CE27-4060-910E-DEE9390A9B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39ED7-6F6B-4589-A7D7-93F90FBDE1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24134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B9479DAE-8650-4008-8C86-981D87AAAF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38CDD8-93CD-4644-BA9B-AD1F7738B8B3}" type="datetimeFigureOut">
              <a:rPr kumimoji="1" lang="ja-JP" altLang="en-US" smtClean="0"/>
              <a:t>2023/5/1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6E9E79E-813C-40DD-AE52-5EDA8E32CE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2ED0299D-7089-4B8E-B446-41774C96B5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39ED7-6F6B-4589-A7D7-93F90FBDE1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58811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AB7AC5D-9B68-4BFD-AA04-3B33DC5DB4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0F9D398-E06A-41A6-8B6C-1D441DFA0E5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08D6AC1-5B60-4F2D-9CDD-08BB026A9E0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BA30990-55BB-47DC-A1EA-4B0A73F25C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38CDD8-93CD-4644-BA9B-AD1F7738B8B3}" type="datetimeFigureOut">
              <a:rPr kumimoji="1" lang="ja-JP" altLang="en-US" smtClean="0"/>
              <a:t>2023/5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B481886-02EE-43E1-BE23-E081855FCD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538D6B4-5B89-480F-960E-1944326CC2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39ED7-6F6B-4589-A7D7-93F90FBDE1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30965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1022A7C-ACAE-430F-B368-7CE1C0AD28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ED3DFBC4-D28D-4AFD-8888-859B6BB200C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9438405-32F4-4822-B1B1-BD12C6CA75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649D696-70ED-43F6-957B-572FA6C516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38CDD8-93CD-4644-BA9B-AD1F7738B8B3}" type="datetimeFigureOut">
              <a:rPr kumimoji="1" lang="ja-JP" altLang="en-US" smtClean="0"/>
              <a:t>2023/5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1518C46-C3A7-468F-886E-1712B8BBDC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BB25805-4BC7-4DAF-9AA2-2F49B30883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39ED7-6F6B-4589-A7D7-93F90FBDE1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93567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4DF8ADAC-78CC-43C5-A778-AF2C6D4D7F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2A17849-3898-40A0-AF32-A6A01D1AEF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8EE8C5F-B35C-49D7-B7EA-3FB7274109C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38CDD8-93CD-4644-BA9B-AD1F7738B8B3}" type="datetimeFigureOut">
              <a:rPr kumimoji="1" lang="ja-JP" altLang="en-US" smtClean="0"/>
              <a:t>2023/5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AC62B2F-1F7C-46EB-9E4A-CA7FC82CD24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1AA7C4D-1BE6-40E0-95CF-81EB061D68B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439ED7-6F6B-4589-A7D7-93F90FBDE1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05578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79" name="表 279">
            <a:extLst>
              <a:ext uri="{FF2B5EF4-FFF2-40B4-BE49-F238E27FC236}">
                <a16:creationId xmlns:a16="http://schemas.microsoft.com/office/drawing/2014/main" id="{C14DE845-190B-4CAA-ADAF-0F62AD33794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95180217"/>
              </p:ext>
            </p:extLst>
          </p:nvPr>
        </p:nvGraphicFramePr>
        <p:xfrm>
          <a:off x="624840" y="472205"/>
          <a:ext cx="11105532" cy="24688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33948">
                  <a:extLst>
                    <a:ext uri="{9D8B030D-6E8A-4147-A177-3AD203B41FA5}">
                      <a16:colId xmlns:a16="http://schemas.microsoft.com/office/drawing/2014/main" val="2936356804"/>
                    </a:ext>
                  </a:extLst>
                </a:gridCol>
                <a:gridCol w="1233948">
                  <a:extLst>
                    <a:ext uri="{9D8B030D-6E8A-4147-A177-3AD203B41FA5}">
                      <a16:colId xmlns:a16="http://schemas.microsoft.com/office/drawing/2014/main" val="847262655"/>
                    </a:ext>
                  </a:extLst>
                </a:gridCol>
                <a:gridCol w="1233948">
                  <a:extLst>
                    <a:ext uri="{9D8B030D-6E8A-4147-A177-3AD203B41FA5}">
                      <a16:colId xmlns:a16="http://schemas.microsoft.com/office/drawing/2014/main" val="1488353662"/>
                    </a:ext>
                  </a:extLst>
                </a:gridCol>
                <a:gridCol w="1233948">
                  <a:extLst>
                    <a:ext uri="{9D8B030D-6E8A-4147-A177-3AD203B41FA5}">
                      <a16:colId xmlns:a16="http://schemas.microsoft.com/office/drawing/2014/main" val="1705974964"/>
                    </a:ext>
                  </a:extLst>
                </a:gridCol>
                <a:gridCol w="1233948">
                  <a:extLst>
                    <a:ext uri="{9D8B030D-6E8A-4147-A177-3AD203B41FA5}">
                      <a16:colId xmlns:a16="http://schemas.microsoft.com/office/drawing/2014/main" val="1353802738"/>
                    </a:ext>
                  </a:extLst>
                </a:gridCol>
                <a:gridCol w="1233948">
                  <a:extLst>
                    <a:ext uri="{9D8B030D-6E8A-4147-A177-3AD203B41FA5}">
                      <a16:colId xmlns:a16="http://schemas.microsoft.com/office/drawing/2014/main" val="1869056671"/>
                    </a:ext>
                  </a:extLst>
                </a:gridCol>
                <a:gridCol w="1233948">
                  <a:extLst>
                    <a:ext uri="{9D8B030D-6E8A-4147-A177-3AD203B41FA5}">
                      <a16:colId xmlns:a16="http://schemas.microsoft.com/office/drawing/2014/main" val="4115268005"/>
                    </a:ext>
                  </a:extLst>
                </a:gridCol>
                <a:gridCol w="1233948">
                  <a:extLst>
                    <a:ext uri="{9D8B030D-6E8A-4147-A177-3AD203B41FA5}">
                      <a16:colId xmlns:a16="http://schemas.microsoft.com/office/drawing/2014/main" val="606619278"/>
                    </a:ext>
                  </a:extLst>
                </a:gridCol>
                <a:gridCol w="1233948">
                  <a:extLst>
                    <a:ext uri="{9D8B030D-6E8A-4147-A177-3AD203B41FA5}">
                      <a16:colId xmlns:a16="http://schemas.microsoft.com/office/drawing/2014/main" val="3474048774"/>
                    </a:ext>
                  </a:extLst>
                </a:gridCol>
              </a:tblGrid>
              <a:tr h="236212">
                <a:tc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7"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formance measure</a:t>
                      </a:r>
                      <a:endParaRPr kumimoji="1" lang="ja-JP" altLang="en-US" sz="12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2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54447364"/>
                  </a:ext>
                </a:extLst>
              </a:tr>
              <a:tr h="236212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V_model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uracy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st_accuracy</a:t>
                      </a:r>
                      <a:endParaRPr kumimoji="1" lang="ja-JP" altLang="en-US" sz="12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C_ROC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st_auc_roc</a:t>
                      </a:r>
                      <a:endParaRPr kumimoji="1" lang="ja-JP" altLang="en-US" sz="12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call</a:t>
                      </a:r>
                      <a:r>
                        <a:rPr kumimoji="1" lang="ja-JP" alt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C 3-5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st_recall_CPC3-5</a:t>
                      </a:r>
                      <a:endParaRPr kumimoji="1" lang="ja-JP" altLang="en-US" sz="12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call CPC1/2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set_recall_CPC1/2</a:t>
                      </a:r>
                      <a:endParaRPr kumimoji="1" lang="ja-JP" altLang="en-US" sz="12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32329287"/>
                  </a:ext>
                </a:extLst>
              </a:tr>
              <a:tr h="236212">
                <a:tc>
                  <a:txBody>
                    <a:bodyPr/>
                    <a:lstStyle/>
                    <a:p>
                      <a:pPr algn="ctr"/>
                      <a:endParaRPr kumimoji="1" lang="ja-JP" altLang="en-US" sz="12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lidation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st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lidation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st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lidation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st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lidation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st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94241693"/>
                  </a:ext>
                </a:extLst>
              </a:tr>
              <a:tr h="236212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el_1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5</a:t>
                      </a:r>
                      <a:endParaRPr kumimoji="1" lang="ja-JP" altLang="en-US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</a:t>
                      </a:r>
                      <a:endParaRPr kumimoji="1" lang="ja-JP" altLang="en-US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</a:t>
                      </a:r>
                      <a:endParaRPr kumimoji="1" lang="ja-JP" altLang="en-US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</a:t>
                      </a:r>
                      <a:endParaRPr kumimoji="1" lang="ja-JP" altLang="en-US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</a:t>
                      </a:r>
                      <a:endParaRPr kumimoji="1" lang="ja-JP" altLang="en-US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0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0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55421548"/>
                  </a:ext>
                </a:extLst>
              </a:tr>
              <a:tr h="236212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el_2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</a:t>
                      </a:r>
                      <a:endParaRPr kumimoji="1" lang="ja-JP" altLang="en-US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5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</a:t>
                      </a:r>
                      <a:endParaRPr kumimoji="1" lang="ja-JP" altLang="en-US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</a:t>
                      </a:r>
                      <a:endParaRPr kumimoji="1" lang="ja-JP" altLang="en-US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</a:t>
                      </a:r>
                      <a:endParaRPr kumimoji="1" lang="ja-JP" altLang="en-US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9</a:t>
                      </a:r>
                      <a:endParaRPr kumimoji="1" lang="ja-JP" altLang="en-US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0</a:t>
                      </a:r>
                      <a:endParaRPr kumimoji="1" lang="ja-JP" altLang="en-US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0647508"/>
                  </a:ext>
                </a:extLst>
              </a:tr>
              <a:tr h="236212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el_3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mpd="sng"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</a:t>
                      </a:r>
                      <a:endParaRPr kumimoji="1" lang="ja-JP" altLang="en-US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mpd="sng"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5</a:t>
                      </a:r>
                      <a:endParaRPr kumimoji="1" lang="ja-JP" altLang="en-US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mpd="sng"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mpd="sng"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mpd="sng"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mpd="sng"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</a:t>
                      </a:r>
                      <a:endParaRPr kumimoji="1" lang="ja-JP" altLang="en-US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mpd="sng"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0</a:t>
                      </a:r>
                      <a:endParaRPr kumimoji="1" lang="ja-JP" altLang="en-US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mpd="sng"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1</a:t>
                      </a:r>
                      <a:endParaRPr kumimoji="1" lang="ja-JP" altLang="en-US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mpd="sng"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71783863"/>
                  </a:ext>
                </a:extLst>
              </a:tr>
              <a:tr h="236212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el_4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</a:t>
                      </a:r>
                      <a:endParaRPr kumimoji="1" lang="ja-JP" altLang="en-US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</a:t>
                      </a:r>
                      <a:endParaRPr kumimoji="1" lang="ja-JP" altLang="en-US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</a:t>
                      </a:r>
                      <a:endParaRPr kumimoji="1" lang="ja-JP" altLang="en-US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</a:t>
                      </a:r>
                      <a:endParaRPr kumimoji="1" lang="ja-JP" altLang="en-US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</a:t>
                      </a:r>
                      <a:endParaRPr kumimoji="1" lang="ja-JP" altLang="en-US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9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9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48201863"/>
                  </a:ext>
                </a:extLst>
              </a:tr>
              <a:tr h="236212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el_5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</a:t>
                      </a:r>
                      <a:endParaRPr kumimoji="1" lang="ja-JP" altLang="en-US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5</a:t>
                      </a:r>
                      <a:endParaRPr kumimoji="1" lang="ja-JP" altLang="en-US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</a:t>
                      </a:r>
                      <a:endParaRPr kumimoji="1" lang="ja-JP" altLang="en-US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</a:t>
                      </a:r>
                      <a:endParaRPr kumimoji="1" lang="ja-JP" altLang="en-US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</a:t>
                      </a:r>
                      <a:endParaRPr kumimoji="1" lang="ja-JP" altLang="en-US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</a:t>
                      </a:r>
                      <a:endParaRPr kumimoji="1" lang="ja-JP" altLang="en-US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0</a:t>
                      </a:r>
                      <a:endParaRPr kumimoji="1" lang="ja-JP" altLang="en-US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0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69527957"/>
                  </a:ext>
                </a:extLst>
              </a:tr>
              <a:tr h="236212">
                <a:tc gridSpan="8">
                  <a:txBody>
                    <a:bodyPr/>
                    <a:lstStyle/>
                    <a:p>
                      <a:pPr algn="l"/>
                      <a:r>
                        <a:rPr kumimoji="1" lang="en-US" altLang="ja-JP" sz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V: cross validation, AUC: area under curve, ROC: receiver operating characteristic, CPC: cerebral performance category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4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4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4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4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4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68437067"/>
                  </a:ext>
                </a:extLst>
              </a:tr>
            </a:tbl>
          </a:graphicData>
        </a:graphic>
      </p:graphicFrame>
      <p:pic>
        <p:nvPicPr>
          <p:cNvPr id="3" name="図 2">
            <a:extLst>
              <a:ext uri="{FF2B5EF4-FFF2-40B4-BE49-F238E27FC236}">
                <a16:creationId xmlns:a16="http://schemas.microsoft.com/office/drawing/2014/main" id="{42680CE1-A347-95F6-A561-C4CD72372A8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1628" y="3011425"/>
            <a:ext cx="5134530" cy="37473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480245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99</TotalTime>
  <Words>99</Words>
  <Application>Microsoft Office PowerPoint</Application>
  <PresentationFormat>ワイド画面</PresentationFormat>
  <Paragraphs>6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川井 廉之</dc:creator>
  <cp:lastModifiedBy>川井 廉之</cp:lastModifiedBy>
  <cp:revision>23</cp:revision>
  <dcterms:created xsi:type="dcterms:W3CDTF">2022-03-20T00:03:20Z</dcterms:created>
  <dcterms:modified xsi:type="dcterms:W3CDTF">2023-05-18T14:10:55Z</dcterms:modified>
</cp:coreProperties>
</file>